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0" saveSubsetFonts="1">
  <p:sldMasterIdLst>
    <p:sldMasterId id="2147483672" r:id="rId1"/>
  </p:sldMasterIdLst>
  <p:notesMasterIdLst>
    <p:notesMasterId r:id="rId3"/>
  </p:notesMasterIdLst>
  <p:sldIdLst>
    <p:sldId id="289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17"/>
    <a:srgbClr val="ED7322"/>
    <a:srgbClr val="7131A2"/>
    <a:srgbClr val="72AD4B"/>
    <a:srgbClr val="FEC000"/>
    <a:srgbClr val="054288"/>
    <a:srgbClr val="C1C1C1"/>
    <a:srgbClr val="3A6BC5"/>
    <a:srgbClr val="FD51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843"/>
    <p:restoredTop sz="91374"/>
  </p:normalViewPr>
  <p:slideViewPr>
    <p:cSldViewPr snapToGrid="0">
      <p:cViewPr varScale="1">
        <p:scale>
          <a:sx n="68" d="100"/>
          <a:sy n="68" d="100"/>
        </p:scale>
        <p:origin x="305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0EFDD5-8F86-466A-89D7-25B3DB95DCF7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515836-92F9-4349-9A8B-5F3582848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40279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5137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8726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3208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7389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638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6040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3540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32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561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9737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1030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012CA6-A36D-405A-BB9B-70FE73A8A50C}" type="datetimeFigureOut">
              <a:rPr lang="zh-CN" altLang="en-US" smtClean="0"/>
              <a:t>2021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6C2B7D-C95A-43A8-8889-3EDDE8E8CA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6009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29E2E021-9D8A-FA4F-9B40-99473B82CC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8992351"/>
              </p:ext>
            </p:extLst>
          </p:nvPr>
        </p:nvGraphicFramePr>
        <p:xfrm>
          <a:off x="1145727" y="1482164"/>
          <a:ext cx="4566546" cy="506412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52000">
                  <a:extLst>
                    <a:ext uri="{9D8B030D-6E8A-4147-A177-3AD203B41FA5}">
                      <a16:colId xmlns:a16="http://schemas.microsoft.com/office/drawing/2014/main" val="3368287345"/>
                    </a:ext>
                  </a:extLst>
                </a:gridCol>
                <a:gridCol w="660233">
                  <a:extLst>
                    <a:ext uri="{9D8B030D-6E8A-4147-A177-3AD203B41FA5}">
                      <a16:colId xmlns:a16="http://schemas.microsoft.com/office/drawing/2014/main" val="3200754380"/>
                    </a:ext>
                  </a:extLst>
                </a:gridCol>
                <a:gridCol w="826294">
                  <a:extLst>
                    <a:ext uri="{9D8B030D-6E8A-4147-A177-3AD203B41FA5}">
                      <a16:colId xmlns:a16="http://schemas.microsoft.com/office/drawing/2014/main" val="871522568"/>
                    </a:ext>
                  </a:extLst>
                </a:gridCol>
                <a:gridCol w="826294">
                  <a:extLst>
                    <a:ext uri="{9D8B030D-6E8A-4147-A177-3AD203B41FA5}">
                      <a16:colId xmlns:a16="http://schemas.microsoft.com/office/drawing/2014/main" val="1905162041"/>
                    </a:ext>
                  </a:extLst>
                </a:gridCol>
                <a:gridCol w="1101725">
                  <a:extLst>
                    <a:ext uri="{9D8B030D-6E8A-4147-A177-3AD203B41FA5}">
                      <a16:colId xmlns:a16="http://schemas.microsoft.com/office/drawing/2014/main" val="86326822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</a:rPr>
                        <a:t>Surgery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</a:rPr>
                        <a:t>TMA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i="1" u="none" strike="noStrike" dirty="0">
                          <a:effectLst/>
                        </a:rPr>
                        <a:t>P</a:t>
                      </a:r>
                      <a:endParaRPr lang="en" sz="1200" b="0" i="1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8461367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 err="1">
                          <a:effectLst/>
                        </a:rPr>
                        <a:t>Age（years</a:t>
                      </a:r>
                      <a:r>
                        <a:rPr lang="en-US" sz="1200" u="none" strike="noStrike" dirty="0">
                          <a:effectLst/>
                        </a:rPr>
                        <a:t>）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≤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0.665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61498729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60-7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19267948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&gt;7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1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2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94462918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r>
                        <a:rPr lang="en" sz="1200" u="none" strike="noStrike" dirty="0">
                          <a:effectLst/>
                        </a:rPr>
                        <a:t>Sex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</a:rPr>
                        <a:t>Mal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5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5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0.4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99391601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</a:rPr>
                        <a:t>Femal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1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65317137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r>
                        <a:rPr lang="en" sz="1200" u="none" strike="noStrike" dirty="0">
                          <a:effectLst/>
                        </a:rPr>
                        <a:t>Location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</a:rPr>
                        <a:t>Upper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0.28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02645902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</a:rPr>
                        <a:t>Middl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2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9693512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</a:rPr>
                        <a:t>Lower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3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11384543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</a:rPr>
                        <a:t>Unknown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9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0642155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lvl="0" indent="0" algn="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sz="1200" u="none" strike="noStrike">
                          <a:effectLst/>
                        </a:rPr>
                        <a:t>Pathologic </a:t>
                      </a:r>
                      <a:r>
                        <a:rPr lang="en" altLang="zh-CN" sz="1200" u="none" strike="noStrike">
                          <a:effectLst/>
                        </a:rPr>
                        <a:t>stag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0.7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06386153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5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4311799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l" fontAlgn="t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I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59312371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r>
                        <a:rPr lang="en" sz="1200" u="none" strike="noStrike">
                          <a:effectLst/>
                        </a:rPr>
                        <a:t>TNM stage 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+I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3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0.87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08602617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II+I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77138209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r>
                        <a:rPr lang="en" sz="1200" u="none" strike="noStrike">
                          <a:effectLst/>
                        </a:rPr>
                        <a:t>T stage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0.193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82411339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73744403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I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9360979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r" fontAlgn="ctr"/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</a:rPr>
                        <a:t>IV 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98585025"/>
                  </a:ext>
                </a:extLst>
              </a:tr>
              <a:tr h="215900"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" sz="1200" u="none" strike="noStrike" dirty="0">
                          <a:effectLst/>
                        </a:rPr>
                        <a:t>N stage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</a:rPr>
                        <a:t>N0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 dirty="0">
                          <a:effectLst/>
                        </a:rPr>
                        <a:t>0.09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9155027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</a:rPr>
                        <a:t>N1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14515123"/>
                  </a:ext>
                </a:extLst>
              </a:tr>
              <a:tr h="212725">
                <a:tc rowSpan="2">
                  <a:txBody>
                    <a:bodyPr/>
                    <a:lstStyle/>
                    <a:p>
                      <a:pPr algn="r" fontAlgn="ctr"/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824522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>
                          <a:effectLst/>
                        </a:rPr>
                        <a:t>N2</a:t>
                      </a:r>
                      <a:endParaRPr lang="e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u="none" strike="noStrike">
                          <a:effectLst/>
                        </a:rPr>
                        <a:t>1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0186851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r" fontAlgn="ctr"/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6903215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200" u="none" strike="noStrike" dirty="0">
                          <a:effectLst/>
                        </a:rPr>
                        <a:t>N3</a:t>
                      </a:r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0229286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r" fontAlgn="ctr"/>
                      <a:endParaRPr lang="e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0628383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373ADD3E-5E99-F94A-993C-2CE0F1559F5F}"/>
              </a:ext>
            </a:extLst>
          </p:cNvPr>
          <p:cNvSpPr txBox="1"/>
          <p:nvPr/>
        </p:nvSpPr>
        <p:spPr>
          <a:xfrm>
            <a:off x="1267768" y="1205165"/>
            <a:ext cx="43224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Table S1. Summary of the patients’ clinicopathological information</a:t>
            </a:r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450613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55</TotalTime>
  <Words>106</Words>
  <Application>Microsoft Macintosh PowerPoint</Application>
  <PresentationFormat>A4 纸张(210x297 毫米)</PresentationFormat>
  <Paragraphs>8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zhoululin</cp:lastModifiedBy>
  <cp:revision>140</cp:revision>
  <dcterms:created xsi:type="dcterms:W3CDTF">2020-02-26T09:57:01Z</dcterms:created>
  <dcterms:modified xsi:type="dcterms:W3CDTF">2021-05-12T12:17:36Z</dcterms:modified>
</cp:coreProperties>
</file>